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6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68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4808" y="4075867"/>
            <a:ext cx="3540421" cy="265276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3" name="Rectangle 2"/>
          <p:cNvSpPr/>
          <p:nvPr/>
        </p:nvSpPr>
        <p:spPr>
          <a:xfrm>
            <a:off x="263772" y="6943647"/>
            <a:ext cx="5953649" cy="4802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923"/>
              </a:spcAft>
            </a:pPr>
            <a:r>
              <a:rPr lang="fr-FR" sz="1108" dirty="0" err="1" smtClean="0">
                <a:latin typeface="Helvetica" charset="0"/>
                <a:ea typeface="Helvetica" charset="0"/>
                <a:cs typeface="Helvetica" charset="0"/>
              </a:rPr>
              <a:t>Glomerulus</a:t>
            </a:r>
            <a:r>
              <a:rPr lang="fr-FR" sz="1108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showing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mesangial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hypercellularity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with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segmental 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fibrocellular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crescent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.  (PAS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staining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, x200)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61C91B02-3302-184C-9EAF-0805EC68CC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4808" y="2657165"/>
            <a:ext cx="1735015" cy="94956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xmlns="" id="{5810F438-3660-694B-9DB9-D3CD983EDB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59017" y="2657165"/>
            <a:ext cx="1506212" cy="94956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xmlns="" id="{1AC7C91E-6418-4743-ADA7-0C8FE130DED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9203" b="8980"/>
          <a:stretch/>
        </p:blipFill>
        <p:spPr>
          <a:xfrm>
            <a:off x="3359017" y="1703909"/>
            <a:ext cx="1506212" cy="832344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xmlns="" id="{373668B9-A166-4B44-93D9-F9B234A3F0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24808" y="1703909"/>
            <a:ext cx="1735015" cy="832339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938260" y="133457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a</a:t>
            </a:r>
          </a:p>
        </p:txBody>
      </p:sp>
      <p:sp>
        <p:nvSpPr>
          <p:cNvPr id="9" name="TextBox 7"/>
          <p:cNvSpPr txBox="1"/>
          <p:nvPr/>
        </p:nvSpPr>
        <p:spPr>
          <a:xfrm>
            <a:off x="914971" y="371013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b</a:t>
            </a:r>
          </a:p>
        </p:txBody>
      </p:sp>
      <p:sp>
        <p:nvSpPr>
          <p:cNvPr id="10" name="Rettangolo 9"/>
          <p:cNvSpPr/>
          <p:nvPr/>
        </p:nvSpPr>
        <p:spPr>
          <a:xfrm>
            <a:off x="317500" y="469669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1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167158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20</Words>
  <Application>Microsoft Macintosh PowerPoint</Application>
  <PresentationFormat>Presentazione su schermo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8:52:39Z</dcterms:modified>
</cp:coreProperties>
</file>